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1324D-D7E8-408C-B3AB-4430681EE9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317EC-30EB-4C86-AA3C-7C82108448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C0777-03F2-4FB9-8E18-9B31FE2109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028BF-3594-4944-AA5E-FC653CF14D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0E4CA-9205-424E-878D-A99AF5932E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D2AA2-8B11-4530-961A-FF45434682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170B1-D8D2-4053-882A-45D00A13A4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A40DC-4A5F-4B7E-B46C-D58520EF2C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C3452-EFCC-450C-A8C6-B470EA15AA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93DA1-AE5A-4B54-A04C-6D6CD71238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2EED7-93E0-4EB2-A0C6-B9B6944B07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76AC7-D4D6-4CD0-8249-1E2B994051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0ACE8D-836F-45AF-8F34-C3413D88A0DF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933560" y="914400"/>
            <a:ext cx="2706840" cy="1800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1933560" y="2857680"/>
            <a:ext cx="2706840" cy="1800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tretch/>
        </p:blipFill>
        <p:spPr>
          <a:xfrm>
            <a:off x="4643280" y="2857680"/>
            <a:ext cx="2706840" cy="1800000"/>
          </a:xfrm>
          <a:prstGeom prst="rect">
            <a:avLst/>
          </a:prstGeom>
          <a:ln w="0">
            <a:noFill/>
          </a:ln>
        </p:spPr>
      </p:pic>
      <p:sp>
        <p:nvSpPr>
          <p:cNvPr id="44" name="ZoneTexte 8"/>
          <p:cNvSpPr/>
          <p:nvPr/>
        </p:nvSpPr>
        <p:spPr>
          <a:xfrm>
            <a:off x="2804040" y="1620720"/>
            <a:ext cx="1686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GEC50= 4.7± 0.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6" descr=""/>
          <p:cNvPicPr/>
          <p:nvPr/>
        </p:nvPicPr>
        <p:blipFill>
          <a:blip r:embed="rId4"/>
          <a:stretch/>
        </p:blipFill>
        <p:spPr>
          <a:xfrm>
            <a:off x="4640400" y="914400"/>
            <a:ext cx="2706480" cy="1800360"/>
          </a:xfrm>
          <a:prstGeom prst="rect">
            <a:avLst/>
          </a:prstGeom>
          <a:ln w="0">
            <a:noFill/>
          </a:ln>
        </p:spPr>
      </p:pic>
      <p:sp>
        <p:nvSpPr>
          <p:cNvPr id="46" name="ZoneTexte 11"/>
          <p:cNvSpPr/>
          <p:nvPr/>
        </p:nvSpPr>
        <p:spPr>
          <a:xfrm>
            <a:off x="5504040" y="1620720"/>
            <a:ext cx="186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GEC50= 4.88± 0.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12"/>
          <p:cNvSpPr/>
          <p:nvPr/>
        </p:nvSpPr>
        <p:spPr>
          <a:xfrm>
            <a:off x="2860920" y="3549600"/>
            <a:ext cx="1820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GEC50= 5.36 ± 0.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3"/>
          <p:cNvSpPr/>
          <p:nvPr/>
        </p:nvSpPr>
        <p:spPr>
          <a:xfrm>
            <a:off x="5649840" y="3571920"/>
            <a:ext cx="177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GEC50= 5.29± 0.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3"/>
          <p:cNvSpPr/>
          <p:nvPr/>
        </p:nvSpPr>
        <p:spPr>
          <a:xfrm>
            <a:off x="785880" y="4932000"/>
            <a:ext cx="75722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Figure S1. PBP2 induces DC maturation in a dose-dependent manne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Mouse BMDC were stimulated for 48h with the indicated doses of PBP2.  The mean fluorescence intensity (MFI) was determined for each maturation marker depicted in the Y axe of the graphics. LOGEC50 ± SD calculated from two independent experiments is shown in each graphic (µg/ml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0T18:55:54Z</dcterms:created>
  <dc:creator>NAT_2010</dc:creator>
  <dc:description/>
  <dc:language>en-US</dc:language>
  <cp:lastModifiedBy> </cp:lastModifiedBy>
  <dcterms:modified xsi:type="dcterms:W3CDTF">2011-09-26T14:17:48Z</dcterms:modified>
  <cp:revision>2</cp:revision>
  <dc:subject/>
  <dc:title>Diapositive 1</dc:title>
</cp:coreProperties>
</file>